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7199313" cy="102600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ACFDD-6297-4A4E-8832-98CD239E30E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1997DC-2DB8-454A-A98D-91E4792FA62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84D8D3-BC5A-482C-BB1F-342E6D50B81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55132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742280" y="239400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6036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55132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742280" y="5931720"/>
            <a:ext cx="20862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E37F4-6885-45A6-BEDA-A7D8FAD2DF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9BA04F-F5B2-4AD8-979E-1BA9A39F4AB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085C7-EEBF-4C23-8641-BF9CBC5CAE3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82E9A-8A09-4CF5-BE84-8CE8626F884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3BA97C-B3C9-4F68-AFFA-3BC3BB64D1E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60360" y="410760"/>
            <a:ext cx="6480000" cy="7926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25791A-1B43-43DB-929E-7576AD04A8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36D5AD-849E-47C4-82A2-00158BCA74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680640" y="593172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6E4E8-0836-4E33-8445-5429431302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6036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680640" y="2394000"/>
            <a:ext cx="316188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60360" y="5931720"/>
            <a:ext cx="6480000" cy="3230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56D885-ECA6-4F03-8B4E-B5F034CCEFF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60360" y="410760"/>
            <a:ext cx="6480000" cy="170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60360" y="2394000"/>
            <a:ext cx="6480000" cy="6772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600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460600" y="9344160"/>
            <a:ext cx="227952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160600" y="9344160"/>
            <a:ext cx="1679400" cy="712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AED3A92-0AE9-4F73-8A08-3C892ACFBE91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rcRect l="0" t="2073" r="0" b="2852"/>
          <a:stretch/>
        </p:blipFill>
        <p:spPr>
          <a:xfrm>
            <a:off x="628560" y="177840"/>
            <a:ext cx="5816520" cy="7873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247680" y="8178480"/>
            <a:ext cx="6705720" cy="1407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Presentation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2-DE comparison of embryo protein profiles between maize vp5 mutant and its wild type Vp5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,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and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C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represent three biological replicates. About 600 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g embryo proteins were loaded into the 11-cm linear pH 4-7 IPG strips for IEF. Secondary SDS-PAGE was run in 13.5% gels. Digital images were processed using PDQUEST software. Approximately 780±10 CBB-stained protein spots were detected in gel, reproducibly. The differentially expressed embryo protein spots are indicated by arrows and have consistent changes in the three replicate gels, except spot 5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, 17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 and 22 (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雨林木风</cp:lastModifiedBy>
  <dcterms:modified xsi:type="dcterms:W3CDTF">2014-10-20T02:52:47Z</dcterms:modified>
  <cp:revision>3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2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2.PPT</vt:lpwstr>
  </property>
  <property fmtid="{D5CDD505-2E9C-101B-9397-08002B2CF9AE}" pid="6" name="Version">
    <vt:r8>1</vt:r8>
  </property>
</Properties>
</file>